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12192000"/>
  <p:notesSz cx="6888163" cy="100171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 autoAdjust="0"/>
    <p:restoredTop sz="94660"/>
  </p:normalViewPr>
  <p:slideViewPr>
    <p:cSldViewPr snapToGrid="0">
      <p:cViewPr>
        <p:scale>
          <a:sx n="90" d="100"/>
          <a:sy n="90" d="100"/>
        </p:scale>
        <p:origin x="1620" y="-88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7505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0720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5702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2460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8826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5897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6945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2633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1730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9238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2FF19-CFE9-49D5-9A7A-6B9810A7FD6A}" type="datetimeFigureOut">
              <a:rPr lang="es-ES" smtClean="0"/>
              <a:pPr/>
              <a:t>06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174FB-55F5-472E-86E7-AB034F1C85F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6734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9818A392-8D50-A0A0-38F2-17F3C98D2D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4519528"/>
              </p:ext>
            </p:extLst>
          </p:nvPr>
        </p:nvGraphicFramePr>
        <p:xfrm>
          <a:off x="1169496" y="1958085"/>
          <a:ext cx="4478337" cy="2725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477567" imgH="2726006" progId="Prism8.Document">
                  <p:embed/>
                </p:oleObj>
              </mc:Choice>
              <mc:Fallback>
                <p:oleObj name="Prism 8" r:id="rId2" imgW="4477567" imgH="2726006" progId="Prism8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9818A392-8D50-A0A0-38F2-17F3C98D2D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69496" y="1958085"/>
                        <a:ext cx="4478337" cy="2725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C75B9EE0-E030-25D9-76EE-50756BA1ED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1471510"/>
              </p:ext>
            </p:extLst>
          </p:nvPr>
        </p:nvGraphicFramePr>
        <p:xfrm>
          <a:off x="1169496" y="5157054"/>
          <a:ext cx="4532313" cy="3000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532668" imgH="3000443" progId="Prism8.Document">
                  <p:embed/>
                </p:oleObj>
              </mc:Choice>
              <mc:Fallback>
                <p:oleObj name="Prism 8" r:id="rId4" imgW="4532668" imgH="3000443" progId="Prism8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C75B9EE0-E030-25D9-76EE-50756BA1ED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69496" y="5157054"/>
                        <a:ext cx="4532313" cy="3000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9" name="Grupo 8">
            <a:extLst>
              <a:ext uri="{FF2B5EF4-FFF2-40B4-BE49-F238E27FC236}">
                <a16:creationId xmlns:a16="http://schemas.microsoft.com/office/drawing/2014/main" id="{AEA849EF-FE56-31E7-9804-73177C6E915A}"/>
              </a:ext>
            </a:extLst>
          </p:cNvPr>
          <p:cNvGrpSpPr/>
          <p:nvPr/>
        </p:nvGrpSpPr>
        <p:grpSpPr>
          <a:xfrm>
            <a:off x="4063239" y="4154904"/>
            <a:ext cx="102140" cy="102140"/>
            <a:chOff x="4063239" y="4635230"/>
            <a:chExt cx="102140" cy="102140"/>
          </a:xfrm>
        </p:grpSpPr>
        <p:cxnSp>
          <p:nvCxnSpPr>
            <p:cNvPr id="7" name="Conector recto 6">
              <a:extLst>
                <a:ext uri="{FF2B5EF4-FFF2-40B4-BE49-F238E27FC236}">
                  <a16:creationId xmlns:a16="http://schemas.microsoft.com/office/drawing/2014/main" id="{8EAD77FC-CFC7-CFB2-1B03-BFA1C0C47454}"/>
                </a:ext>
              </a:extLst>
            </p:cNvPr>
            <p:cNvCxnSpPr/>
            <p:nvPr/>
          </p:nvCxnSpPr>
          <p:spPr>
            <a:xfrm>
              <a:off x="4114309" y="4635230"/>
              <a:ext cx="0" cy="10214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ctor recto 7">
              <a:extLst>
                <a:ext uri="{FF2B5EF4-FFF2-40B4-BE49-F238E27FC236}">
                  <a16:creationId xmlns:a16="http://schemas.microsoft.com/office/drawing/2014/main" id="{A1A1543A-C56B-DE17-C625-D74805D39497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114309" y="4635230"/>
              <a:ext cx="0" cy="10214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Grupo 9">
            <a:extLst>
              <a:ext uri="{FF2B5EF4-FFF2-40B4-BE49-F238E27FC236}">
                <a16:creationId xmlns:a16="http://schemas.microsoft.com/office/drawing/2014/main" id="{30002035-D3EB-922F-CB73-A1241DB95212}"/>
              </a:ext>
            </a:extLst>
          </p:cNvPr>
          <p:cNvGrpSpPr/>
          <p:nvPr/>
        </p:nvGrpSpPr>
        <p:grpSpPr>
          <a:xfrm>
            <a:off x="4066436" y="7633126"/>
            <a:ext cx="102140" cy="102140"/>
            <a:chOff x="4063239" y="4635230"/>
            <a:chExt cx="102140" cy="102140"/>
          </a:xfrm>
        </p:grpSpPr>
        <p:cxnSp>
          <p:nvCxnSpPr>
            <p:cNvPr id="11" name="Conector recto 10">
              <a:extLst>
                <a:ext uri="{FF2B5EF4-FFF2-40B4-BE49-F238E27FC236}">
                  <a16:creationId xmlns:a16="http://schemas.microsoft.com/office/drawing/2014/main" id="{B7E4F4E4-13F3-FAE7-7FE2-DEF2395BE4D2}"/>
                </a:ext>
              </a:extLst>
            </p:cNvPr>
            <p:cNvCxnSpPr/>
            <p:nvPr/>
          </p:nvCxnSpPr>
          <p:spPr>
            <a:xfrm>
              <a:off x="4114309" y="4635230"/>
              <a:ext cx="0" cy="10214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421473A8-FD49-DEA0-13F0-890DB45FF7C1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114309" y="4635230"/>
              <a:ext cx="0" cy="10214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A8F47EA2-C203-DD6A-085B-8515C82C66D4}"/>
              </a:ext>
            </a:extLst>
          </p:cNvPr>
          <p:cNvCxnSpPr>
            <a:cxnSpLocks/>
          </p:cNvCxnSpPr>
          <p:nvPr/>
        </p:nvCxnSpPr>
        <p:spPr>
          <a:xfrm rot="5400000">
            <a:off x="3180763" y="7641400"/>
            <a:ext cx="0" cy="1021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346F0062-E1FA-072A-1792-75EFF70C37A2}"/>
              </a:ext>
            </a:extLst>
          </p:cNvPr>
          <p:cNvCxnSpPr>
            <a:cxnSpLocks/>
          </p:cNvCxnSpPr>
          <p:nvPr/>
        </p:nvCxnSpPr>
        <p:spPr>
          <a:xfrm rot="5400000">
            <a:off x="3180763" y="4169588"/>
            <a:ext cx="0" cy="1021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uadroTexto 3">
            <a:extLst>
              <a:ext uri="{FF2B5EF4-FFF2-40B4-BE49-F238E27FC236}">
                <a16:creationId xmlns:a16="http://schemas.microsoft.com/office/drawing/2014/main" id="{6019277F-7E84-7E17-5EDE-E883BD5A65F4}"/>
              </a:ext>
            </a:extLst>
          </p:cNvPr>
          <p:cNvSpPr txBox="1"/>
          <p:nvPr/>
        </p:nvSpPr>
        <p:spPr>
          <a:xfrm>
            <a:off x="1183482" y="9172329"/>
            <a:ext cx="4932981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100" b="1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6</a:t>
            </a:r>
            <a:r>
              <a:rPr lang="en-US" sz="11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Pi  content in leaves of wild-type, miR827 OE (upper panel) and CRISPR-miR827 (lower panel) plants that have been mock-inoculated (-) or inoculated with </a:t>
            </a:r>
            <a:r>
              <a:rPr lang="en-US" sz="1100" i="1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. oryzae </a:t>
            </a:r>
            <a:r>
              <a:rPr lang="en-US" sz="11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ores (+)</a:t>
            </a:r>
            <a:r>
              <a:rPr lang="en-US" sz="1100" kern="1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i content was assessed in leaves at two different positions of the same plant, Leaf 2 and Leaf 3, at 24 hours post-inoculation (</a:t>
            </a:r>
            <a:r>
              <a:rPr lang="en-US" sz="1100" kern="100" dirty="0" err="1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pi</a:t>
            </a:r>
            <a:r>
              <a:rPr lang="en-US" sz="11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Results shown correspond to Leaf 2 (similar results were obtained on leaves at position 3). Bars represent mean ± SEM of 4 biological replicates, each one from a pool of 4 leaves (leaf 2) from independent plants (Two-way ANOVA followed by Tukey’s HSD test). Letters indicate significant differences among conditions.</a:t>
            </a:r>
          </a:p>
        </p:txBody>
      </p:sp>
    </p:spTree>
    <p:extLst>
      <p:ext uri="{BB962C8B-B14F-4D97-AF65-F5344CB8AC3E}">
        <p14:creationId xmlns:p14="http://schemas.microsoft.com/office/powerpoint/2010/main" val="40538222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6</TotalTime>
  <Words>123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8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lanca San Segundo de los Mozos</dc:creator>
  <cp:lastModifiedBy>Blanca San Segundo de los Mozos</cp:lastModifiedBy>
  <cp:revision>63</cp:revision>
  <cp:lastPrinted>2024-03-17T11:02:51Z</cp:lastPrinted>
  <dcterms:created xsi:type="dcterms:W3CDTF">2022-08-14T09:50:05Z</dcterms:created>
  <dcterms:modified xsi:type="dcterms:W3CDTF">2024-08-06T07:16:39Z</dcterms:modified>
</cp:coreProperties>
</file>